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94" d="100"/>
          <a:sy n="94" d="100"/>
        </p:scale>
        <p:origin x="-528" y="32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504407-F727-6643-96A2-756424CEC70C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9FBCA2-C875-544E-A29C-4D9EB9CC37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328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Exp.25_16</a:t>
            </a:r>
            <a:r>
              <a:rPr kumimoji="1" lang="ja-JP" altLang="en-US" dirty="0" smtClean="0"/>
              <a:t>（</a:t>
            </a:r>
            <a:r>
              <a:rPr kumimoji="1" lang="en-US" altLang="ja-JP" dirty="0" smtClean="0"/>
              <a:t>n = 8</a:t>
            </a:r>
            <a:r>
              <a:rPr kumimoji="1" lang="ja-JP" altLang="en-US" dirty="0" smtClean="0"/>
              <a:t>）</a:t>
            </a:r>
            <a:r>
              <a:rPr kumimoji="1" lang="en-US" altLang="ja-JP" dirty="0" smtClean="0"/>
              <a:t> SI (A, B), IHC for Iba1(C)</a:t>
            </a:r>
          </a:p>
          <a:p>
            <a:r>
              <a:rPr kumimoji="1" lang="en-US" altLang="ja-JP" dirty="0" smtClean="0"/>
              <a:t>MI-17 (</a:t>
            </a:r>
            <a:r>
              <a:rPr kumimoji="1" lang="en-US" altLang="ja-JP" smtClean="0"/>
              <a:t>D) (n = 6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88E33F-A977-B94E-A196-A6A0594E4AD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5931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707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260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450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562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06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615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378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096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5052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927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06050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233DF-24FA-A741-84B6-9C81E720C514}" type="datetimeFigureOut">
              <a:rPr kumimoji="1" lang="ja-JP" altLang="en-US" smtClean="0"/>
              <a:t>16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7277C-9E18-6F4A-B9CF-9F9D71E580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4871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65623" y="326030"/>
            <a:ext cx="85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"/>
                <a:cs typeface="Times"/>
              </a:rPr>
              <a:t>Fig. S2</a:t>
            </a:r>
            <a:endParaRPr kumimoji="1" lang="ja-JP" altLang="en-US" dirty="0">
              <a:latin typeface="Times"/>
              <a:cs typeface="Times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782662" y="789836"/>
            <a:ext cx="409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A</a:t>
            </a:r>
            <a:r>
              <a:rPr kumimoji="1" lang="en-US" altLang="ja-JP" b="1" dirty="0" smtClean="0">
                <a:latin typeface="Times"/>
                <a:cs typeface="Times"/>
              </a:rPr>
              <a:t>.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82332" y="789836"/>
            <a:ext cx="396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"/>
                <a:cs typeface="Times"/>
              </a:rPr>
              <a:t>B. 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782662" y="3822149"/>
            <a:ext cx="409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C</a:t>
            </a:r>
            <a:r>
              <a:rPr kumimoji="1" lang="en-US" altLang="ja-JP" b="1" dirty="0" smtClean="0">
                <a:latin typeface="Times"/>
                <a:cs typeface="Times"/>
              </a:rPr>
              <a:t>.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582332" y="3822149"/>
            <a:ext cx="409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D</a:t>
            </a:r>
            <a:r>
              <a:rPr kumimoji="1" lang="en-US" altLang="ja-JP" b="1" dirty="0" smtClean="0">
                <a:latin typeface="Times"/>
                <a:cs typeface="Times"/>
              </a:rPr>
              <a:t>.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132975" y="221391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1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132975" y="180581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2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132975" y="1397725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3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132975" y="262200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"/>
                <a:cs typeface="Times"/>
              </a:rPr>
              <a:t>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549266" y="1984553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SI ratio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77874" y="2893422"/>
            <a:ext cx="11871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KS (1.0 g/kg)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793938" y="2875641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"/>
                <a:cs typeface="Times"/>
              </a:rPr>
              <a:t>-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688397" y="2875641"/>
            <a:ext cx="316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+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cxnSp>
        <p:nvCxnSpPr>
          <p:cNvPr id="23" name="直線コネクタ 22"/>
          <p:cNvCxnSpPr/>
          <p:nvPr/>
        </p:nvCxnSpPr>
        <p:spPr>
          <a:xfrm>
            <a:off x="4647227" y="3244973"/>
            <a:ext cx="704003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40"/>
          <p:cNvSpPr txBox="1"/>
          <p:nvPr/>
        </p:nvSpPr>
        <p:spPr>
          <a:xfrm>
            <a:off x="4542121" y="3216955"/>
            <a:ext cx="914931" cy="461665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 smtClean="0">
                <a:latin typeface="Times"/>
                <a:cs typeface="Times"/>
              </a:rPr>
              <a:t>Aggressor</a:t>
            </a:r>
          </a:p>
          <a:p>
            <a:pPr algn="ctr"/>
            <a:r>
              <a:rPr lang="en-US" sz="1200" b="1" dirty="0" smtClean="0">
                <a:latin typeface="Times"/>
                <a:cs typeface="Times"/>
              </a:rPr>
              <a:t>(-)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458353" y="2892942"/>
            <a:ext cx="11871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KS (1.0 g/kg)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686077" y="2846286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"/>
                <a:cs typeface="Times"/>
              </a:rPr>
              <a:t>-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035030" y="2846286"/>
            <a:ext cx="316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+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666019" y="2846286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"/>
                <a:cs typeface="Times"/>
              </a:rPr>
              <a:t>-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013220" y="2846286"/>
            <a:ext cx="316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+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cxnSp>
        <p:nvCxnSpPr>
          <p:cNvPr id="33" name="直線コネクタ 32"/>
          <p:cNvCxnSpPr/>
          <p:nvPr/>
        </p:nvCxnSpPr>
        <p:spPr>
          <a:xfrm>
            <a:off x="5658971" y="3244973"/>
            <a:ext cx="704003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40"/>
          <p:cNvSpPr txBox="1"/>
          <p:nvPr/>
        </p:nvSpPr>
        <p:spPr>
          <a:xfrm>
            <a:off x="5542167" y="3216955"/>
            <a:ext cx="914931" cy="461665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 smtClean="0">
                <a:latin typeface="Times"/>
                <a:cs typeface="Times"/>
              </a:rPr>
              <a:t>Aggressor</a:t>
            </a:r>
          </a:p>
          <a:p>
            <a:pPr algn="ctr"/>
            <a:r>
              <a:rPr lang="en-US" sz="1200" b="1" dirty="0" smtClean="0">
                <a:latin typeface="Times"/>
                <a:cs typeface="Times"/>
              </a:rPr>
              <a:t>(</a:t>
            </a:r>
            <a:r>
              <a:rPr lang="en-US" sz="1200" b="1" dirty="0">
                <a:latin typeface="Times"/>
                <a:cs typeface="Times"/>
              </a:rPr>
              <a:t>+</a:t>
            </a:r>
            <a:r>
              <a:rPr lang="en-US" sz="1200" b="1" dirty="0" smtClean="0">
                <a:latin typeface="Times"/>
                <a:cs typeface="Times"/>
              </a:rPr>
              <a:t>)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990589" y="2030488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Times"/>
                <a:cs typeface="Times"/>
              </a:rPr>
              <a:t>10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990589" y="1732807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Times"/>
                <a:cs typeface="Times"/>
              </a:rPr>
              <a:t>15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990589" y="1435126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Times"/>
                <a:cs typeface="Times"/>
              </a:rPr>
              <a:t>20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080358" y="232816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Times"/>
                <a:cs typeface="Times"/>
              </a:rPr>
              <a:t>5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4259894" y="262585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Times"/>
                <a:cs typeface="Times"/>
              </a:rPr>
              <a:t>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 rot="16200000">
            <a:off x="3161401" y="1924981"/>
            <a:ext cx="12234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"/>
                <a:cs typeface="Times"/>
              </a:rPr>
              <a:t>Distance moved</a:t>
            </a:r>
          </a:p>
          <a:p>
            <a:pPr algn="ctr"/>
            <a:r>
              <a:rPr lang="en-US" altLang="ja-JP" sz="1200" b="1" dirty="0" smtClean="0">
                <a:latin typeface="Times"/>
                <a:cs typeface="Times"/>
              </a:rPr>
              <a:t> (cm/150 sec)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cxnSp>
        <p:nvCxnSpPr>
          <p:cNvPr id="43" name="直線コネクタ 42"/>
          <p:cNvCxnSpPr/>
          <p:nvPr/>
        </p:nvCxnSpPr>
        <p:spPr>
          <a:xfrm>
            <a:off x="4617414" y="6457469"/>
            <a:ext cx="704003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0"/>
          <p:cNvSpPr txBox="1"/>
          <p:nvPr/>
        </p:nvSpPr>
        <p:spPr>
          <a:xfrm>
            <a:off x="4512308" y="6521784"/>
            <a:ext cx="914931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 smtClean="0">
                <a:latin typeface="Times"/>
                <a:cs typeface="Times"/>
              </a:rPr>
              <a:t>PBS</a:t>
            </a: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469070" y="6105438"/>
            <a:ext cx="11871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KS (1.0 g/kg)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656264" y="6058782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"/>
                <a:cs typeface="Times"/>
              </a:rPr>
              <a:t>-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005217" y="6058782"/>
            <a:ext cx="316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+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653220" y="6058782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"/>
                <a:cs typeface="Times"/>
              </a:rPr>
              <a:t>-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6013931" y="6058782"/>
            <a:ext cx="316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+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cxnSp>
        <p:nvCxnSpPr>
          <p:cNvPr id="50" name="直線コネクタ 49"/>
          <p:cNvCxnSpPr/>
          <p:nvPr/>
        </p:nvCxnSpPr>
        <p:spPr>
          <a:xfrm>
            <a:off x="5646172" y="6457469"/>
            <a:ext cx="704003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40"/>
          <p:cNvSpPr txBox="1"/>
          <p:nvPr/>
        </p:nvSpPr>
        <p:spPr>
          <a:xfrm>
            <a:off x="5529368" y="6463306"/>
            <a:ext cx="914931" cy="39395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altLang="ja-JP" sz="1200" b="1" dirty="0">
                <a:latin typeface="Times"/>
                <a:cs typeface="Times"/>
              </a:rPr>
              <a:t>LPS</a:t>
            </a:r>
          </a:p>
          <a:p>
            <a:pPr algn="ctr">
              <a:lnSpc>
                <a:spcPct val="80000"/>
              </a:lnSpc>
            </a:pPr>
            <a:r>
              <a:rPr lang="en-US" altLang="ja-JP" sz="1200" b="1" dirty="0">
                <a:latin typeface="Times"/>
                <a:cs typeface="Times"/>
              </a:rPr>
              <a:t>(0.1 </a:t>
            </a:r>
            <a:r>
              <a:rPr lang="en-US" altLang="ja-JP" sz="1200" b="1" dirty="0">
                <a:latin typeface="Symbol" charset="2"/>
                <a:cs typeface="Symbol" charset="2"/>
              </a:rPr>
              <a:t>m</a:t>
            </a:r>
            <a:r>
              <a:rPr lang="en-US" altLang="ja-JP" sz="1200" b="1" dirty="0">
                <a:latin typeface="Times"/>
                <a:cs typeface="Times"/>
              </a:rPr>
              <a:t>g/ml)</a:t>
            </a:r>
          </a:p>
        </p:txBody>
      </p:sp>
      <p:sp>
        <p:nvSpPr>
          <p:cNvPr id="52" name="テキスト ボックス 51"/>
          <p:cNvSpPr txBox="1"/>
          <p:nvPr/>
        </p:nvSpPr>
        <p:spPr>
          <a:xfrm rot="16200000">
            <a:off x="3222437" y="5214290"/>
            <a:ext cx="1127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 smtClean="0">
                <a:latin typeface="Times"/>
                <a:cs typeface="Times"/>
              </a:rPr>
              <a:t>IL-6 (</a:t>
            </a:r>
            <a:r>
              <a:rPr lang="en-US" altLang="ja-JP" sz="1400" b="1" dirty="0" err="1" smtClean="0">
                <a:latin typeface="Times"/>
                <a:cs typeface="Times"/>
              </a:rPr>
              <a:t>pg</a:t>
            </a:r>
            <a:r>
              <a:rPr lang="en-US" altLang="ja-JP" sz="1400" b="1" dirty="0" smtClean="0">
                <a:latin typeface="Times"/>
                <a:cs typeface="Times"/>
              </a:rPr>
              <a:t>/ml)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4056809" y="542252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"/>
                <a:cs typeface="Times"/>
              </a:rPr>
              <a:t>4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4056809" y="5177671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"/>
                <a:cs typeface="Times"/>
              </a:rPr>
              <a:t>6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967040" y="4687957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"/>
                <a:cs typeface="Times"/>
              </a:rPr>
              <a:t>10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4056809" y="5667385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"/>
                <a:cs typeface="Times"/>
              </a:rPr>
              <a:t>2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236345" y="591224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"/>
                <a:cs typeface="Times"/>
              </a:rPr>
              <a:t>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4056809" y="493281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"/>
                <a:cs typeface="Times"/>
              </a:rPr>
              <a:t>8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4297" y="4555046"/>
            <a:ext cx="1926255" cy="1371089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8054" y="6089013"/>
            <a:ext cx="1932498" cy="1375533"/>
          </a:xfrm>
          <a:prstGeom prst="rect">
            <a:avLst/>
          </a:prstGeom>
        </p:spPr>
      </p:pic>
      <p:sp>
        <p:nvSpPr>
          <p:cNvPr id="59" name="テキスト ボックス 58"/>
          <p:cNvSpPr txBox="1"/>
          <p:nvPr/>
        </p:nvSpPr>
        <p:spPr>
          <a:xfrm>
            <a:off x="912716" y="5208462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20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912716" y="4966171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30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912716" y="4481589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50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912716" y="5450753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10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1182021" y="569304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912716" y="472388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Times"/>
                <a:cs typeface="Times"/>
              </a:rPr>
              <a:t>400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1182195" y="663107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4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1182195" y="632527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6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182195" y="693686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2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182195" y="724266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Times"/>
                <a:cs typeface="Times"/>
              </a:rPr>
              <a:t>0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1182195" y="6019484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8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 rot="16200000">
            <a:off x="151257" y="4959681"/>
            <a:ext cx="9760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Iba1</a:t>
            </a:r>
            <a:r>
              <a:rPr lang="en-US" altLang="ja-JP" sz="1400" b="1" baseline="30000" dirty="0" smtClean="0">
                <a:latin typeface="Times"/>
                <a:cs typeface="Times"/>
              </a:rPr>
              <a:t>+</a:t>
            </a:r>
            <a:r>
              <a:rPr lang="en-US" altLang="ja-JP" sz="1400" b="1" dirty="0" smtClean="0">
                <a:latin typeface="Times"/>
                <a:cs typeface="Times"/>
              </a:rPr>
              <a:t> cells </a:t>
            </a:r>
          </a:p>
          <a:p>
            <a:r>
              <a:rPr lang="en-US" altLang="ja-JP" sz="1400" b="1" dirty="0" smtClean="0">
                <a:latin typeface="Times"/>
                <a:cs typeface="Times"/>
              </a:rPr>
              <a:t>in the DG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 rot="16200000">
            <a:off x="105814" y="6517598"/>
            <a:ext cx="14614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 smtClean="0">
                <a:latin typeface="Times"/>
                <a:cs typeface="Times"/>
              </a:rPr>
              <a:t>Iba1</a:t>
            </a:r>
            <a:r>
              <a:rPr lang="en-US" altLang="ja-JP" sz="1400" b="1" baseline="30000" dirty="0" smtClean="0">
                <a:latin typeface="Times"/>
                <a:cs typeface="Times"/>
              </a:rPr>
              <a:t>+</a:t>
            </a:r>
            <a:r>
              <a:rPr lang="en-US" altLang="ja-JP" sz="1400" b="1" dirty="0" smtClean="0">
                <a:latin typeface="Times"/>
                <a:cs typeface="Times"/>
              </a:rPr>
              <a:t> aggregates</a:t>
            </a:r>
          </a:p>
          <a:p>
            <a:pPr algn="ctr"/>
            <a:r>
              <a:rPr lang="en-US" altLang="ja-JP" sz="1400" b="1" dirty="0" smtClean="0">
                <a:latin typeface="Times"/>
                <a:cs typeface="Times"/>
              </a:rPr>
              <a:t>in the DG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74" name="正方形/長方形 73"/>
          <p:cNvSpPr/>
          <p:nvPr/>
        </p:nvSpPr>
        <p:spPr>
          <a:xfrm>
            <a:off x="1651226" y="4014145"/>
            <a:ext cx="228143" cy="125115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正方形/長方形 74"/>
          <p:cNvSpPr/>
          <p:nvPr/>
        </p:nvSpPr>
        <p:spPr>
          <a:xfrm>
            <a:off x="2460254" y="4014145"/>
            <a:ext cx="228143" cy="125115"/>
          </a:xfrm>
          <a:prstGeom prst="rect">
            <a:avLst/>
          </a:prstGeom>
          <a:solidFill>
            <a:srgbClr val="FC00FE"/>
          </a:solidFill>
          <a:ln>
            <a:solidFill>
              <a:srgbClr val="FC00FE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6" name="正方形/長方形 75"/>
          <p:cNvSpPr/>
          <p:nvPr/>
        </p:nvSpPr>
        <p:spPr>
          <a:xfrm>
            <a:off x="1651226" y="4297741"/>
            <a:ext cx="228143" cy="125115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76"/>
          <p:cNvSpPr/>
          <p:nvPr/>
        </p:nvSpPr>
        <p:spPr>
          <a:xfrm>
            <a:off x="2460254" y="4305598"/>
            <a:ext cx="228143" cy="125115"/>
          </a:xfrm>
          <a:prstGeom prst="rect">
            <a:avLst/>
          </a:prstGeom>
          <a:solidFill>
            <a:srgbClr val="22FF15"/>
          </a:solidFill>
          <a:ln>
            <a:solidFill>
              <a:srgbClr val="22FF1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2693612" y="4211560"/>
            <a:ext cx="543739" cy="276999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altLang="ja-JP" sz="1200" b="1" dirty="0" err="1">
                <a:latin typeface="Times"/>
                <a:cs typeface="Times"/>
              </a:rPr>
              <a:t>H</a:t>
            </a:r>
            <a:r>
              <a:rPr kumimoji="1" lang="en-US" altLang="ja-JP" sz="1200" b="1" dirty="0" err="1" smtClean="0">
                <a:latin typeface="Times"/>
                <a:cs typeface="Times"/>
              </a:rPr>
              <a:t>ilus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2693612" y="3920873"/>
            <a:ext cx="492593" cy="276999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Times"/>
                <a:cs typeface="Times"/>
              </a:rPr>
              <a:t>SGZ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1846100" y="4213534"/>
            <a:ext cx="518141" cy="276999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Times"/>
                <a:cs typeface="Times"/>
              </a:rPr>
              <a:t>GCL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1846100" y="3938526"/>
            <a:ext cx="556563" cy="276999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Times"/>
                <a:cs typeface="Times"/>
              </a:rPr>
              <a:t>MOL</a:t>
            </a:r>
            <a:endParaRPr kumimoji="1" lang="ja-JP" altLang="en-US" sz="1200" b="1" dirty="0">
              <a:latin typeface="Times"/>
              <a:cs typeface="Times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377874" y="7542561"/>
            <a:ext cx="11871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KS (1.0 g/kg)</a:t>
            </a:r>
            <a:endParaRPr kumimoji="1" lang="ja-JP" altLang="en-US" sz="1400" b="1" dirty="0">
              <a:latin typeface="Times"/>
              <a:cs typeface="Times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1793938" y="7524780"/>
            <a:ext cx="26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"/>
                <a:cs typeface="Times"/>
              </a:rPr>
              <a:t>-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2688397" y="7524780"/>
            <a:ext cx="316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/>
                <a:cs typeface="Times"/>
              </a:rPr>
              <a:t>+</a:t>
            </a:r>
            <a:endParaRPr kumimoji="1" lang="ja-JP" altLang="en-US" b="1" dirty="0">
              <a:latin typeface="Times"/>
              <a:cs typeface="Times"/>
            </a:endParaRPr>
          </a:p>
        </p:txBody>
      </p:sp>
      <p:pic>
        <p:nvPicPr>
          <p:cNvPr id="4" name="図 3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418054" y="1465121"/>
            <a:ext cx="1944000" cy="1403998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24289" y="1501121"/>
            <a:ext cx="1921906" cy="1367998"/>
          </a:xfrm>
          <a:prstGeom prst="rect">
            <a:avLst/>
          </a:prstGeom>
        </p:spPr>
      </p:pic>
      <p:pic>
        <p:nvPicPr>
          <p:cNvPr id="26" name="図 2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82589" y="4750584"/>
            <a:ext cx="1963606" cy="1397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244149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1</Words>
  <Application>Microsoft Macintosh PowerPoint</Application>
  <PresentationFormat>画面に合わせる (4:3)</PresentationFormat>
  <Paragraphs>6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TO NAOKI</dc:creator>
  <cp:lastModifiedBy>ITO NAOKI</cp:lastModifiedBy>
  <cp:revision>11</cp:revision>
  <dcterms:created xsi:type="dcterms:W3CDTF">2016-12-22T15:45:54Z</dcterms:created>
  <dcterms:modified xsi:type="dcterms:W3CDTF">2016-12-22T16:03:11Z</dcterms:modified>
</cp:coreProperties>
</file>